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63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2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919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069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05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397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505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242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281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723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0865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A65B2D-11AF-4D95-9468-1D056117B46A}" type="datetimeFigureOut">
              <a:rPr lang="en-US" smtClean="0"/>
              <a:t>3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18BBC-425E-419F-838B-424232A0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41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8890535"/>
              </p:ext>
            </p:extLst>
          </p:nvPr>
        </p:nvGraphicFramePr>
        <p:xfrm>
          <a:off x="1440293" y="461819"/>
          <a:ext cx="9523270" cy="61228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799845">
                  <a:extLst>
                    <a:ext uri="{9D8B030D-6E8A-4147-A177-3AD203B41FA5}">
                      <a16:colId xmlns:a16="http://schemas.microsoft.com/office/drawing/2014/main" val="1221427251"/>
                    </a:ext>
                  </a:extLst>
                </a:gridCol>
                <a:gridCol w="1548589">
                  <a:extLst>
                    <a:ext uri="{9D8B030D-6E8A-4147-A177-3AD203B41FA5}">
                      <a16:colId xmlns:a16="http://schemas.microsoft.com/office/drawing/2014/main" val="3149599912"/>
                    </a:ext>
                  </a:extLst>
                </a:gridCol>
                <a:gridCol w="1062182">
                  <a:extLst>
                    <a:ext uri="{9D8B030D-6E8A-4147-A177-3AD203B41FA5}">
                      <a16:colId xmlns:a16="http://schemas.microsoft.com/office/drawing/2014/main" val="860740225"/>
                    </a:ext>
                  </a:extLst>
                </a:gridCol>
                <a:gridCol w="1644073">
                  <a:extLst>
                    <a:ext uri="{9D8B030D-6E8A-4147-A177-3AD203B41FA5}">
                      <a16:colId xmlns:a16="http://schemas.microsoft.com/office/drawing/2014/main" val="19948104"/>
                    </a:ext>
                  </a:extLst>
                </a:gridCol>
                <a:gridCol w="1468581">
                  <a:extLst>
                    <a:ext uri="{9D8B030D-6E8A-4147-A177-3AD203B41FA5}">
                      <a16:colId xmlns:a16="http://schemas.microsoft.com/office/drawing/2014/main" val="3648923708"/>
                    </a:ext>
                  </a:extLst>
                </a:gridCol>
              </a:tblGrid>
              <a:tr h="480291">
                <a:tc>
                  <a:txBody>
                    <a:bodyPr/>
                    <a:lstStyle/>
                    <a:p>
                      <a:pPr algn="l" fontAlgn="b"/>
                      <a:endParaRPr lang="en-US" sz="14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</a:t>
                      </a:r>
                      <a:r>
                        <a:rPr lang="en-US" sz="14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 Subjects Taking</a:t>
                      </a:r>
                      <a:endParaRPr lang="en-US" sz="14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ECG</a:t>
                      </a:r>
                      <a:endParaRPr lang="en-US" sz="14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normal ECG</a:t>
                      </a:r>
                      <a:endParaRPr lang="en-US" sz="14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 smtClean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duction  Abnormality</a:t>
                      </a:r>
                      <a:endParaRPr lang="en-US" sz="14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5465531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LODIPI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8140967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EPILEPTIC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3246067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HISTAMINES FOR SYSTEMIC US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2908939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 GRIP DESCONGESTIVO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3807681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PROFLOXACI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3226975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IDIN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6697577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BIVEN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4062934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CLOFEN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4860235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NEPHRIN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8773199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VOFLOXACI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9495508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DOCAIN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491713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PHENIDAT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1620809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PHENIDATE HYDROCHLORID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7028832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OCLOPRAMID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4010500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LOXACI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1541768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CETAMOL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1692427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TASSIUM CHLORID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9277401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EUDOEPHEDRIN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9064420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EUDOEPHEDRINE HYDROCHLORID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392082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ETIAPIN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1938283"/>
                  </a:ext>
                </a:extLst>
              </a:tr>
              <a:tr h="2686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ETID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32256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11717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25</TotalTime>
  <Words>123</Words>
  <Application>Microsoft Office PowerPoint</Application>
  <PresentationFormat>Widescreen</PresentationFormat>
  <Paragraphs>10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CS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u, Samuel</dc:creator>
  <cp:lastModifiedBy>Kou, Samuel</cp:lastModifiedBy>
  <cp:revision>3</cp:revision>
  <dcterms:created xsi:type="dcterms:W3CDTF">2020-03-14T18:57:41Z</dcterms:created>
  <dcterms:modified xsi:type="dcterms:W3CDTF">2020-03-18T18:23:03Z</dcterms:modified>
</cp:coreProperties>
</file>